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6054E21-1E88-4715-ACCD-547193368BA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340404B-C31D-48BC-AC28-4067930FA73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0F10EF7-BC02-4D9E-B0A6-C25BF76E10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F0FDD-86E3-449E-B3A4-A0D41BDE5D3B}" type="datetimeFigureOut">
              <a:rPr lang="zh-CN" altLang="en-US" smtClean="0"/>
              <a:t>2019/2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5AB2B35-B728-4735-A676-109AFEE514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AEFC76D-F593-4CC7-A373-06986D3B3E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8EEC9-BCC3-425A-9EBF-2EDCC66A7C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46844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3F42818-CC12-4127-9853-545371965A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71C9EA2-C323-4D11-B731-BA11735919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5725088-8665-4332-AD56-EBB2AECC8D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F0FDD-86E3-449E-B3A4-A0D41BDE5D3B}" type="datetimeFigureOut">
              <a:rPr lang="zh-CN" altLang="en-US" smtClean="0"/>
              <a:t>2019/2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9CD9300-4650-4FED-A066-A9EB13F0A6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E4BAE6A-D144-40BD-B878-10B4217754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8EEC9-BCC3-425A-9EBF-2EDCC66A7C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89581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3D070FD-AE5B-40A1-8C6A-1EA5CD9CC1E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5E098F5-4B03-4ADC-8182-8A9D82D491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4C5AA50-96CE-4969-9A43-BEC5136087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F0FDD-86E3-449E-B3A4-A0D41BDE5D3B}" type="datetimeFigureOut">
              <a:rPr lang="zh-CN" altLang="en-US" smtClean="0"/>
              <a:t>2019/2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D5C4856-A908-4E7A-A901-530C6F27E4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0F11274-AF0C-4A76-82E7-30315B5240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8EEC9-BCC3-425A-9EBF-2EDCC66A7C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65243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DBFF691-DAF9-4BDA-81A9-566D786D36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31C0237-7DB5-43EE-A349-DEB38BB1623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FCE2590-943D-4951-88E8-CF32B733FD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F0FDD-86E3-449E-B3A4-A0D41BDE5D3B}" type="datetimeFigureOut">
              <a:rPr lang="zh-CN" altLang="en-US" smtClean="0"/>
              <a:t>2019/2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A5ED2DE-D38B-46A0-B0F8-873EFB5591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1D34487-711F-4D46-986A-BB0EC656C7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8EEC9-BCC3-425A-9EBF-2EDCC66A7C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14606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21FB6FC-A4C4-49CD-9BC2-6FDAE34444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C31CC96-D6EF-4E14-98B7-CFFFF96199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D99459D-BA3F-4EBC-BA3F-A5069B1666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F0FDD-86E3-449E-B3A4-A0D41BDE5D3B}" type="datetimeFigureOut">
              <a:rPr lang="zh-CN" altLang="en-US" smtClean="0"/>
              <a:t>2019/2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567406E-442E-43B7-A264-F83B4E6BE1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5D8B7AD-6C49-434C-BBF1-8F920D1573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8EEC9-BCC3-425A-9EBF-2EDCC66A7C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20479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CDE063-52A9-4312-869C-F596B2398E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4DAF51C-E363-4490-BE16-CF16C660155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2502F12-2EE4-434D-9044-9F94E6ECC1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9959190-4F29-4156-A212-23DA00BB57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F0FDD-86E3-449E-B3A4-A0D41BDE5D3B}" type="datetimeFigureOut">
              <a:rPr lang="zh-CN" altLang="en-US" smtClean="0"/>
              <a:t>2019/2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184C992-FDAD-42A2-9CCE-272DFABEB5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05C80C3-8453-46DE-97AE-F089A382A3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8EEC9-BCC3-425A-9EBF-2EDCC66A7C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5529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34AE7E-F89F-4104-B350-565458D966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15C13D0-D4A9-4531-B189-08C8337931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C01FDCB-5E50-4C7B-86F5-81CF99153C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9ABEC96-6C44-470A-B0DE-B8B27212AE0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8DE314C-27C8-475D-BDED-DD0B31719E5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DF615D6-C89F-4C8F-A961-1D1472B6D7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F0FDD-86E3-449E-B3A4-A0D41BDE5D3B}" type="datetimeFigureOut">
              <a:rPr lang="zh-CN" altLang="en-US" smtClean="0"/>
              <a:t>2019/2/2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51016B16-4F1F-41BB-A541-0156C94BF4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A8298F6-E059-4964-86A7-63A45C63FA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8EEC9-BCC3-425A-9EBF-2EDCC66A7C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1801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C823EDD-3BE1-45BD-8C32-4B26EF429D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7580CBC-B327-4AF6-9465-B277E58C0E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F0FDD-86E3-449E-B3A4-A0D41BDE5D3B}" type="datetimeFigureOut">
              <a:rPr lang="zh-CN" altLang="en-US" smtClean="0"/>
              <a:t>2019/2/2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A07E015-B9C9-4C41-A2BE-01C7A4125E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0F95171-346C-43BD-BA5D-85E91DDA8B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8EEC9-BCC3-425A-9EBF-2EDCC66A7C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13215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DD46D07-DDCC-4A97-9537-26C86D9084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F0FDD-86E3-449E-B3A4-A0D41BDE5D3B}" type="datetimeFigureOut">
              <a:rPr lang="zh-CN" altLang="en-US" smtClean="0"/>
              <a:t>2019/2/2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4D22185-7C60-4739-ADA9-A0FA3BCAF3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4170FBD-10BC-4127-A3D3-DC811D2377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8EEC9-BCC3-425A-9EBF-2EDCC66A7C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57603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8C2FE97-D703-483D-A237-E143B01807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0688CF1-9A1B-414F-A517-2D680625B2F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E03A90C-50D7-4F57-A05A-EB77C07CC4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70B6BC6-8954-4031-9EBD-748EDDB7A2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F0FDD-86E3-449E-B3A4-A0D41BDE5D3B}" type="datetimeFigureOut">
              <a:rPr lang="zh-CN" altLang="en-US" smtClean="0"/>
              <a:t>2019/2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358A5C0-3725-48E5-9757-DDA58B274E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09BAFFF-5ED8-418A-A496-5631D19A1B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8EEC9-BCC3-425A-9EBF-2EDCC66A7C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53369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957EF10-5F22-4E21-9DEF-10996C6DB4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E0A36DE-3A24-41A0-9AEC-4B2D298C023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A338346-BE35-4991-AEF8-B8D3D3FC61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71D66D5-6680-4252-AC1C-8531491B64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CF0FDD-86E3-449E-B3A4-A0D41BDE5D3B}" type="datetimeFigureOut">
              <a:rPr lang="zh-CN" altLang="en-US" smtClean="0"/>
              <a:t>2019/2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E20D907-42A9-43F8-9468-4A04FE0923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B2E33ED-48CD-488F-A375-BF7CF39DF0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8EEC9-BCC3-425A-9EBF-2EDCC66A7C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07551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C732C5A-8BB1-4F67-840B-DB9BC8AC36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D42B06C-EB4D-4783-ADE1-96806078AC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7044A12-0665-4DD0-B3EA-62E7C56D8E5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CF0FDD-86E3-449E-B3A4-A0D41BDE5D3B}" type="datetimeFigureOut">
              <a:rPr lang="zh-CN" altLang="en-US" smtClean="0"/>
              <a:t>2019/2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53C5E3D-CD60-4E5D-92BC-C2EA3B3311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6BC3D4C-31B3-47D6-AA8E-8D40C08F8B0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18EEC9-BCC3-425A-9EBF-2EDCC66A7C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95358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表格 5">
            <a:extLst>
              <a:ext uri="{FF2B5EF4-FFF2-40B4-BE49-F238E27FC236}">
                <a16:creationId xmlns:a16="http://schemas.microsoft.com/office/drawing/2014/main" id="{E65BF98F-E753-476F-A0EA-BA74775A07F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73838163"/>
              </p:ext>
            </p:extLst>
          </p:nvPr>
        </p:nvGraphicFramePr>
        <p:xfrm>
          <a:off x="2284040" y="2004394"/>
          <a:ext cx="7083922" cy="2849211"/>
        </p:xfrm>
        <a:graphic>
          <a:graphicData uri="http://schemas.openxmlformats.org/drawingml/2006/table">
            <a:tbl>
              <a:tblPr firstRow="1" firstCol="1" bandRow="1"/>
              <a:tblGrid>
                <a:gridCol w="1048660">
                  <a:extLst>
                    <a:ext uri="{9D8B030D-6E8A-4147-A177-3AD203B41FA5}">
                      <a16:colId xmlns:a16="http://schemas.microsoft.com/office/drawing/2014/main" val="2499664933"/>
                    </a:ext>
                  </a:extLst>
                </a:gridCol>
                <a:gridCol w="4286145">
                  <a:extLst>
                    <a:ext uri="{9D8B030D-6E8A-4147-A177-3AD203B41FA5}">
                      <a16:colId xmlns:a16="http://schemas.microsoft.com/office/drawing/2014/main" val="1883739618"/>
                    </a:ext>
                  </a:extLst>
                </a:gridCol>
                <a:gridCol w="1749117">
                  <a:extLst>
                    <a:ext uri="{9D8B030D-6E8A-4147-A177-3AD203B41FA5}">
                      <a16:colId xmlns:a16="http://schemas.microsoft.com/office/drawing/2014/main" val="2293641153"/>
                    </a:ext>
                  </a:extLst>
                </a:gridCol>
              </a:tblGrid>
              <a:tr h="31657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ene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rimer sequence (5'-3')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ccession number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768397"/>
                  </a:ext>
                </a:extLst>
              </a:tr>
              <a:tr h="31657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nail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orward: TAGCGAGTGGTTCTTCTGCG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M_005985.4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2685558"/>
                  </a:ext>
                </a:extLst>
              </a:tr>
              <a:tr h="31657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everse: AGATGAGCATTGGCAGCGAG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55548918"/>
                  </a:ext>
                </a:extLst>
              </a:tr>
              <a:tr h="31657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lug</a:t>
                      </a:r>
                      <a:endParaRPr lang="zh-CN" sz="11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orward: TGGGCTGCCCAAACATAAG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M_003068.5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1051522"/>
                  </a:ext>
                </a:extLst>
              </a:tr>
              <a:tr h="31657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everse:</a:t>
                      </a:r>
                      <a:r>
                        <a:rPr lang="en-US" sz="11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CGCAGATCTTGCAAACACA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65935291"/>
                  </a:ext>
                </a:extLst>
              </a:tr>
              <a:tr h="31657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Zeb1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orward: AGAGCGCTAGCTGCCAATAA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XM_017016597.1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1978682"/>
                  </a:ext>
                </a:extLst>
              </a:tr>
              <a:tr h="31657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everse: GGGCGGTGTAGAATCAGAGT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559351"/>
                  </a:ext>
                </a:extLst>
              </a:tr>
              <a:tr h="31657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dvTT3713a231+03"/>
                          <a:cs typeface="Times New Roman" panose="02020603050405020304" pitchFamily="18" charset="0"/>
                        </a:rPr>
                        <a:t>GAPDH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orward: AGAAGGCTGGGGCTCATTTG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M_031144.3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86061697"/>
                  </a:ext>
                </a:extLst>
              </a:tr>
              <a:tr h="316579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4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everse: AGGGGCCATCCACAGTCTTC</a:t>
                      </a:r>
                      <a:endParaRPr lang="zh-CN" sz="11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 </a:t>
                      </a:r>
                      <a:endParaRPr lang="zh-CN" sz="11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01792160"/>
                  </a:ext>
                </a:extLst>
              </a:tr>
            </a:tbl>
          </a:graphicData>
        </a:graphic>
      </p:graphicFrame>
      <p:sp>
        <p:nvSpPr>
          <p:cNvPr id="7" name="Rectangle 2">
            <a:extLst>
              <a:ext uri="{FF2B5EF4-FFF2-40B4-BE49-F238E27FC236}">
                <a16:creationId xmlns:a16="http://schemas.microsoft.com/office/drawing/2014/main" id="{A7F236ED-F5FD-4945-B803-BF9145E2450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43824" y="1434101"/>
            <a:ext cx="4241033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Table. S1 </a:t>
            </a:r>
            <a:r>
              <a:rPr kumimoji="0" lang="en-US" altLang="zh-CN" sz="16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Primer sequences.</a:t>
            </a:r>
            <a:endParaRPr kumimoji="0" lang="en-US" altLang="zh-CN" sz="24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A4904AB0-C281-411E-A0E8-89EF68D5EBCE}"/>
              </a:ext>
            </a:extLst>
          </p:cNvPr>
          <p:cNvSpPr/>
          <p:nvPr/>
        </p:nvSpPr>
        <p:spPr>
          <a:xfrm>
            <a:off x="473493" y="270315"/>
            <a:ext cx="24384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upplementary Table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54671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35955582-D7BA-4D61-8B9E-4B415FE5EA7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9179" y="1931363"/>
            <a:ext cx="10168061" cy="2168356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167326FC-F832-4DB8-966C-C4472D014367}"/>
              </a:ext>
            </a:extLst>
          </p:cNvPr>
          <p:cNvSpPr txBox="1"/>
          <p:nvPr/>
        </p:nvSpPr>
        <p:spPr>
          <a:xfrm>
            <a:off x="1035550" y="1562031"/>
            <a:ext cx="3401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A</a:t>
            </a:r>
            <a:endParaRPr lang="zh-CN" altLang="en-US" b="1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9BF72140-0F20-43EA-B44D-ACF56BEDC1AF}"/>
              </a:ext>
            </a:extLst>
          </p:cNvPr>
          <p:cNvSpPr txBox="1"/>
          <p:nvPr/>
        </p:nvSpPr>
        <p:spPr>
          <a:xfrm>
            <a:off x="6129199" y="1562031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B</a:t>
            </a:r>
            <a:endParaRPr lang="zh-CN" altLang="en-US" b="1" dirty="0"/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E36AFB94-ACA2-4B21-BF3C-41732B45527E}"/>
              </a:ext>
            </a:extLst>
          </p:cNvPr>
          <p:cNvSpPr/>
          <p:nvPr/>
        </p:nvSpPr>
        <p:spPr>
          <a:xfrm>
            <a:off x="393567" y="376846"/>
            <a:ext cx="245612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upplementary Figures</a:t>
            </a:r>
            <a:endParaRPr lang="zh-CN" altLang="en-US" dirty="0"/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30FD3B00-C5CF-4D6B-B297-017EEAC0171E}"/>
              </a:ext>
            </a:extLst>
          </p:cNvPr>
          <p:cNvSpPr/>
          <p:nvPr/>
        </p:nvSpPr>
        <p:spPr>
          <a:xfrm>
            <a:off x="1375708" y="4284385"/>
            <a:ext cx="9703624" cy="8002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r>
              <a: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。</a:t>
            </a:r>
            <a:r>
              <a:rPr lang="zh-CN" altLang="zh-CN" dirty="0"/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A549 cells and H460 cells were treated with 0.25, 0.5, or 1 μM Ang II for 24 h and subjected to western blot analysis of TGF-β. GAPDH was used as a loading control. (B A549 cells and H460 cells were treated with 0.5 μM Ang II for 6, 12, or 24 h and subjected to western blot analysis of TGF-β.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61519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38</Words>
  <Application>Microsoft Office PowerPoint</Application>
  <PresentationFormat>宽屏</PresentationFormat>
  <Paragraphs>33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雨辰 王</dc:creator>
  <cp:lastModifiedBy>雨辰 王</cp:lastModifiedBy>
  <cp:revision>2</cp:revision>
  <dcterms:created xsi:type="dcterms:W3CDTF">2019-02-21T05:25:53Z</dcterms:created>
  <dcterms:modified xsi:type="dcterms:W3CDTF">2019-02-21T05:34:40Z</dcterms:modified>
</cp:coreProperties>
</file>